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567"/>
  </p:normalViewPr>
  <p:slideViewPr>
    <p:cSldViewPr snapToGrid="0" snapToObjects="1">
      <p:cViewPr varScale="1">
        <p:scale>
          <a:sx n="55" d="100"/>
          <a:sy n="55" d="100"/>
        </p:scale>
        <p:origin x="313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EFB47-5D77-6545-AC15-9824C99F2918}" type="datetimeFigureOut">
              <a:rPr lang="en-US" smtClean="0"/>
              <a:t>3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1C786-6A2A-4246-AA07-DF929D548C3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EFB47-5D77-6545-AC15-9824C99F2918}" type="datetimeFigureOut">
              <a:rPr lang="en-US" smtClean="0"/>
              <a:t>3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1C786-6A2A-4246-AA07-DF929D548C3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EFB47-5D77-6545-AC15-9824C99F2918}" type="datetimeFigureOut">
              <a:rPr lang="en-US" smtClean="0"/>
              <a:t>3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1C786-6A2A-4246-AA07-DF929D548C3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EFB47-5D77-6545-AC15-9824C99F2918}" type="datetimeFigureOut">
              <a:rPr lang="en-US" smtClean="0"/>
              <a:t>3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1C786-6A2A-4246-AA07-DF929D548C3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EFB47-5D77-6545-AC15-9824C99F2918}" type="datetimeFigureOut">
              <a:rPr lang="en-US" smtClean="0"/>
              <a:t>3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1C786-6A2A-4246-AA07-DF929D548C3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EFB47-5D77-6545-AC15-9824C99F2918}" type="datetimeFigureOut">
              <a:rPr lang="en-US" smtClean="0"/>
              <a:t>3/1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1C786-6A2A-4246-AA07-DF929D548C3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EFB47-5D77-6545-AC15-9824C99F2918}" type="datetimeFigureOut">
              <a:rPr lang="en-US" smtClean="0"/>
              <a:t>3/19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1C786-6A2A-4246-AA07-DF929D548C3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EFB47-5D77-6545-AC15-9824C99F2918}" type="datetimeFigureOut">
              <a:rPr lang="en-US" smtClean="0"/>
              <a:t>3/19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1C786-6A2A-4246-AA07-DF929D548C3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EFB47-5D77-6545-AC15-9824C99F2918}" type="datetimeFigureOut">
              <a:rPr lang="en-US" smtClean="0"/>
              <a:t>3/19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1C786-6A2A-4246-AA07-DF929D548C3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EFB47-5D77-6545-AC15-9824C99F2918}" type="datetimeFigureOut">
              <a:rPr lang="en-US" smtClean="0"/>
              <a:t>3/1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1C786-6A2A-4246-AA07-DF929D548C3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EFB47-5D77-6545-AC15-9824C99F2918}" type="datetimeFigureOut">
              <a:rPr lang="en-US" smtClean="0"/>
              <a:t>3/1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1C786-6A2A-4246-AA07-DF929D548C3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1EFB47-5D77-6545-AC15-9824C99F2918}" type="datetimeFigureOut">
              <a:rPr lang="en-US" smtClean="0"/>
              <a:t>3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51C786-6A2A-4246-AA07-DF929D548C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17291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9380" y="6096625"/>
            <a:ext cx="5829300" cy="1052583"/>
          </a:xfrm>
        </p:spPr>
        <p:txBody>
          <a:bodyPr>
            <a:normAutofit/>
          </a:bodyPr>
          <a:lstStyle/>
          <a:p>
            <a:pPr algn="l"/>
            <a:r>
              <a:rPr lang="en-US" sz="1800" dirty="0" smtClean="0"/>
              <a:t>Determination of chloramphenicol (Cm) MIC in </a:t>
            </a:r>
            <a:r>
              <a:rPr lang="en-US" sz="1800" i="1" dirty="0" smtClean="0"/>
              <a:t>S. </a:t>
            </a:r>
            <a:r>
              <a:rPr lang="en-US" sz="1800" i="1" dirty="0" err="1" smtClean="0"/>
              <a:t>coelicolor</a:t>
            </a:r>
            <a:r>
              <a:rPr lang="en-US" sz="1800" i="1" dirty="0" smtClean="0"/>
              <a:t> </a:t>
            </a:r>
            <a:r>
              <a:rPr lang="en-US" sz="1800" dirty="0" smtClean="0"/>
              <a:t>MT1110 cultivated on solid SMMS medium. MIC of Cm is &lt; 40 micrograms / ml. </a:t>
            </a:r>
            <a:endParaRPr lang="en-US" sz="1800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12480" y="1200571"/>
            <a:ext cx="5143500" cy="1137895"/>
          </a:xfrm>
        </p:spPr>
        <p:txBody>
          <a:bodyPr>
            <a:normAutofit/>
          </a:bodyPr>
          <a:lstStyle/>
          <a:p>
            <a:pPr algn="l"/>
            <a:r>
              <a:rPr lang="en-US" dirty="0" smtClean="0"/>
              <a:t>Supplementary Figure 1</a:t>
            </a:r>
          </a:p>
          <a:p>
            <a:pPr algn="l"/>
            <a:r>
              <a:rPr lang="en-US" dirty="0" err="1" smtClean="0"/>
              <a:t>Bucca</a:t>
            </a:r>
            <a:r>
              <a:rPr lang="en-US" dirty="0" smtClean="0"/>
              <a:t> et al</a:t>
            </a:r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97" t="41420" b="3498"/>
          <a:stretch/>
        </p:blipFill>
        <p:spPr>
          <a:xfrm>
            <a:off x="223920" y="2828769"/>
            <a:ext cx="6320220" cy="27775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963204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34</Words>
  <Application>Microsoft Macintosh PowerPoint</Application>
  <PresentationFormat>A4 Paper (210x297 mm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Calibri Light</vt:lpstr>
      <vt:lpstr>Arial</vt:lpstr>
      <vt:lpstr>Office Theme</vt:lpstr>
      <vt:lpstr>Determination of chloramphenicol (Cm) MIC in S. coelicolor MT1110 cultivated on solid SMMS medium. MIC of Cm is &lt; 40 micrograms / ml. </vt:lpstr>
    </vt:vector>
  </TitlesOfParts>
  <Company/>
  <LinksUpToDate>false</LinksUpToDate>
  <SharedDoc>false</SharedDoc>
  <HyperlinksChanged>false</HyperlinksChanged>
  <AppVersion>15.003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etermination of chloramphenicol (Cm) MIC in S. coelicolor MT1110 cultivated on solid SMMS medium. MIC of Cm is &lt; 40 micrograms / ml. </dc:title>
  <dc:creator>Colin Smith</dc:creator>
  <cp:lastModifiedBy>Giselda Bucca</cp:lastModifiedBy>
  <cp:revision>2</cp:revision>
  <dcterms:created xsi:type="dcterms:W3CDTF">2018-03-16T15:31:43Z</dcterms:created>
  <dcterms:modified xsi:type="dcterms:W3CDTF">2018-03-19T10:53:28Z</dcterms:modified>
</cp:coreProperties>
</file>